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69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14" autoAdjust="0"/>
    <p:restoredTop sz="94660"/>
  </p:normalViewPr>
  <p:slideViewPr>
    <p:cSldViewPr snapToGrid="0">
      <p:cViewPr varScale="1">
        <p:scale>
          <a:sx n="73" d="100"/>
          <a:sy n="73" d="100"/>
        </p:scale>
        <p:origin x="18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48BE08-A5A9-42FA-8797-43D3F1EF7681}" type="datetimeFigureOut">
              <a:rPr lang="zh-CN" altLang="en-US" smtClean="0"/>
              <a:t>2025/9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2F7B69-4F0D-4A1F-9D40-C3A7D3C804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49589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C6D8891-DF15-4EA0-9643-4A520BFD0CD0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67141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870585-90B2-C061-8F89-BB722A1088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FE94368-F1C3-3E50-AB4B-A807080FCB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3E71B62-DE90-6F04-3D5C-89079F8C2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F95BE-11B7-4E3E-A376-ABC88FA43308}" type="datetimeFigureOut">
              <a:rPr lang="zh-CN" altLang="en-US" smtClean="0"/>
              <a:t>2025/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56256D-37D7-EFCB-B44F-70900EC84A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5D0E442-A216-3DBB-50B2-328B360641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3D37-6533-4B3D-BBB2-41A163DAF0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8078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E03C50-8296-B20F-CFDC-1DBF00A438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C4A136A-5EB5-828D-D41D-EA88CD119B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664EC9F-084F-F759-4B76-E1E4E215C6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F95BE-11B7-4E3E-A376-ABC88FA43308}" type="datetimeFigureOut">
              <a:rPr lang="zh-CN" altLang="en-US" smtClean="0"/>
              <a:t>2025/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80174F5-E465-BE02-3676-EA1DC2FBE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CB5EC4B-C84F-BBE5-2E4A-B4A1C0E308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3D37-6533-4B3D-BBB2-41A163DAF0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8833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8692612-8018-F296-24E1-E34AE2BDA6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E105EDC-B404-936B-6F8E-99CA19B387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D478A67-C275-B053-4E83-42444D7421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F95BE-11B7-4E3E-A376-ABC88FA43308}" type="datetimeFigureOut">
              <a:rPr lang="zh-CN" altLang="en-US" smtClean="0"/>
              <a:t>2025/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DA043A-7462-1B72-F8C6-11CB5BDF7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3DFD543-8E2C-6253-A9B6-ABF8FDD1DB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3D37-6533-4B3D-BBB2-41A163DAF0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48930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96B100-9A43-6ED6-D291-3ABAB9D24C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0DFA526-D479-B41D-98ED-DC30A6ACE5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0BC4A32-C2BA-59C5-FA74-D3A4C5BEE6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F95BE-11B7-4E3E-A376-ABC88FA43308}" type="datetimeFigureOut">
              <a:rPr lang="zh-CN" altLang="en-US" smtClean="0"/>
              <a:t>2025/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7FD5DF-E72F-47A0-AF91-85B827F88E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0150D30-F73A-A40F-3FE5-A87C4362B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3D37-6533-4B3D-BBB2-41A163DAF0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81447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2791D88-3CE9-1EFD-4AFF-7D1125D0FD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2BAB792-3256-13D9-0C98-E2D64EA6AB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B6296A0-A10B-13D4-EFDA-54344D7DA0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F95BE-11B7-4E3E-A376-ABC88FA43308}" type="datetimeFigureOut">
              <a:rPr lang="zh-CN" altLang="en-US" smtClean="0"/>
              <a:t>2025/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7099746-D002-A7C2-D3D3-FA33257489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35EA1D-5A19-B78F-FFFF-7FC4DEABAB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3D37-6533-4B3D-BBB2-41A163DAF0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6951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E458D6-0448-093D-F307-9B11516166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499D440-ABB7-FDD4-0634-BC609BC29F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7C21E22-DAFE-887F-7E16-85843BAF5E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5E57E0D-5BF0-72F2-BC86-FEFD0517B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F95BE-11B7-4E3E-A376-ABC88FA43308}" type="datetimeFigureOut">
              <a:rPr lang="zh-CN" altLang="en-US" smtClean="0"/>
              <a:t>2025/9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415C090-CDE9-B63F-CA2F-24D703A4FA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EA837AF-897A-51B5-E33E-D69D056E08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3D37-6533-4B3D-BBB2-41A163DAF0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1483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C39501C-958A-EC42-F54E-C70169DC6C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215B783-C6D0-8D13-6389-7E00E6BEFA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01AC29D-1823-5C56-8319-8FEA665585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B60B8AF-7432-D643-2438-4F3D9D0CD1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E0DD7B4-445F-E618-1D0A-409407BAEF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C8E561F-3FE8-9340-193E-CB16A6CA4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F95BE-11B7-4E3E-A376-ABC88FA43308}" type="datetimeFigureOut">
              <a:rPr lang="zh-CN" altLang="en-US" smtClean="0"/>
              <a:t>2025/9/2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C411367-BA78-79A5-FCFE-6DA2343EA8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FA1A86C-DC94-BF7B-397D-AF646A3966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3D37-6533-4B3D-BBB2-41A163DAF0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0531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635BC4-70A2-2A1E-54F6-B44E7DEC8F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CE7097A-8A89-7762-BC1D-3038CF6F8C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F95BE-11B7-4E3E-A376-ABC88FA43308}" type="datetimeFigureOut">
              <a:rPr lang="zh-CN" altLang="en-US" smtClean="0"/>
              <a:t>2025/9/2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E41747B-5243-F82F-786A-67CBA4186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4870513-87F5-D8B7-67D3-96B35BBC87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3D37-6533-4B3D-BBB2-41A163DAF0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3363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A98454B-27EC-7486-7611-01E9740E0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F95BE-11B7-4E3E-A376-ABC88FA43308}" type="datetimeFigureOut">
              <a:rPr lang="zh-CN" altLang="en-US" smtClean="0"/>
              <a:t>2025/9/2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438421E-028F-5AF6-BCD6-8767530F8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2A11BDB-AEF4-106B-291A-18295C2C85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3D37-6533-4B3D-BBB2-41A163DAF0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3262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950AA4-E11E-C26E-EAD9-DF6074534C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FB85C67-EE13-1F00-2A6F-1B5D4EC693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8FE3BF7-E513-7C6F-6457-6F5D6D813D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3C5715E-2E7E-DE39-20E4-1E2A178C3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F95BE-11B7-4E3E-A376-ABC88FA43308}" type="datetimeFigureOut">
              <a:rPr lang="zh-CN" altLang="en-US" smtClean="0"/>
              <a:t>2025/9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58C07D2-3CDE-B4E2-63A1-DBB0717CA0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758EC1B-1958-CACA-942F-45ADC6439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3D37-6533-4B3D-BBB2-41A163DAF0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64055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97A3DA-1D0C-3CEE-982E-61E2E9DF6D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43AB82B-DBB7-F1EC-D71C-AB3F5E691C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8852994-8C59-50DB-FC49-9548DCD4AC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201E51F-C7FB-E378-3A8B-73A5BD688C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F95BE-11B7-4E3E-A376-ABC88FA43308}" type="datetimeFigureOut">
              <a:rPr lang="zh-CN" altLang="en-US" smtClean="0"/>
              <a:t>2025/9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EF71A9B-9F84-689E-2E0F-A60A04950A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D351E50-7113-6BAB-4DBB-A412EB556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3D37-6533-4B3D-BBB2-41A163DAF0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8530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7A5F483-5333-1030-7CBF-CB7D005C7D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EF5DDF9-1346-72CE-602A-28B704EC0B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91356C-296E-BEDF-9F0C-940154504E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6F95BE-11B7-4E3E-A376-ABC88FA43308}" type="datetimeFigureOut">
              <a:rPr lang="zh-CN" altLang="en-US" smtClean="0"/>
              <a:t>2025/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E04D2A7-C4F0-0132-A255-1D70DF672C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BF61E2-664D-DF8A-2D4A-FEF7DC73E9F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713D37-6533-4B3D-BBB2-41A163DAF0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386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2400941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20F95BB1-E9EA-6E72-A49F-4D443BAE8DC5}"/>
              </a:ext>
            </a:extLst>
          </p:cNvPr>
          <p:cNvGrpSpPr/>
          <p:nvPr/>
        </p:nvGrpSpPr>
        <p:grpSpPr>
          <a:xfrm>
            <a:off x="2039147" y="50245"/>
            <a:ext cx="7940880" cy="4942864"/>
            <a:chOff x="1986896" y="1278153"/>
            <a:chExt cx="7940880" cy="4942864"/>
          </a:xfrm>
        </p:grpSpPr>
        <p:pic>
          <p:nvPicPr>
            <p:cNvPr id="2" name="7c6402cf9403c33e78447d667962c2b0">
              <a:hlinkClick r:id="" action="ppaction://media"/>
              <a:extLst>
                <a:ext uri="{FF2B5EF4-FFF2-40B4-BE49-F238E27FC236}">
                  <a16:creationId xmlns:a16="http://schemas.microsoft.com/office/drawing/2014/main" id="{57917856-5738-E29A-74BC-57D77037876C}"/>
                </a:ext>
              </a:extLst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>
            <a:blip r:embed="rId5"/>
            <a:stretch>
              <a:fillRect/>
            </a:stretch>
          </p:blipFill>
          <p:spPr>
            <a:xfrm rot="16200000">
              <a:off x="3485904" y="-220855"/>
              <a:ext cx="4942864" cy="7940879"/>
            </a:xfrm>
            <a:prstGeom prst="rect">
              <a:avLst/>
            </a:prstGeom>
          </p:spPr>
        </p:pic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8A831A76-B28E-E493-53B4-2D0DFC79B492}"/>
                </a:ext>
              </a:extLst>
            </p:cNvPr>
            <p:cNvSpPr txBox="1"/>
            <p:nvPr/>
          </p:nvSpPr>
          <p:spPr>
            <a:xfrm>
              <a:off x="2677891" y="2109652"/>
              <a:ext cx="72498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         NC                   Control           2 mg/kg           4 mg/kg</a:t>
              </a:r>
              <a:endParaRPr lang="zh-CN" altLang="en-US" dirty="0"/>
            </a:p>
          </p:txBody>
        </p:sp>
      </p:grpSp>
      <p:sp>
        <p:nvSpPr>
          <p:cNvPr id="6" name="文本框 5">
            <a:extLst>
              <a:ext uri="{FF2B5EF4-FFF2-40B4-BE49-F238E27FC236}">
                <a16:creationId xmlns:a16="http://schemas.microsoft.com/office/drawing/2014/main" id="{0C7B19DC-61F6-ED6F-5CDF-8ECF0465B8A0}"/>
              </a:ext>
            </a:extLst>
          </p:cNvPr>
          <p:cNvSpPr txBox="1"/>
          <p:nvPr/>
        </p:nvSpPr>
        <p:spPr>
          <a:xfrm>
            <a:off x="2039147" y="5362944"/>
            <a:ext cx="794088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1F2329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Video S1. </a:t>
            </a:r>
          </a:p>
          <a:p>
            <a:endParaRPr lang="en-US" altLang="zh-CN" dirty="0">
              <a:solidFill>
                <a:srgbClr val="1F2329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b="0" i="0" dirty="0">
                <a:solidFill>
                  <a:srgbClr val="1F2329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ehavioral changes in mice at the endpoint of the in vivo </a:t>
            </a:r>
            <a:r>
              <a:rPr lang="en-US" altLang="zh-CN" dirty="0">
                <a:solidFill>
                  <a:srgbClr val="1F232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eriment  </a:t>
            </a:r>
            <a:r>
              <a:rPr lang="en-US" altLang="zh-CN" b="0" i="0" dirty="0">
                <a:solidFill>
                  <a:srgbClr val="1F2329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72h)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8199624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宽屏</PresentationFormat>
  <Paragraphs>5</Paragraphs>
  <Slides>2</Slides>
  <Notes>1</Notes>
  <HiddenSlides>0</HiddenSlides>
  <MMClips>1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衍晓 韩</dc:creator>
  <cp:lastModifiedBy>衍晓 韩</cp:lastModifiedBy>
  <cp:revision>1</cp:revision>
  <dcterms:created xsi:type="dcterms:W3CDTF">2025-09-26T20:20:02Z</dcterms:created>
  <dcterms:modified xsi:type="dcterms:W3CDTF">2025-09-26T20:20:28Z</dcterms:modified>
</cp:coreProperties>
</file>